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2923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8978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0763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2912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8237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2597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2750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2123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4961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2267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9194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DEB8A-89E8-4C07-AFED-41E94ED9713E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BC4F2-9EDC-4B7F-83CC-387E544B8C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150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4998700"/>
              </p:ext>
            </p:extLst>
          </p:nvPr>
        </p:nvGraphicFramePr>
        <p:xfrm>
          <a:off x="4170363" y="2105025"/>
          <a:ext cx="3849687" cy="2646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5" r:id="rId3" imgW="3849480" imgH="2647080" progId="Prism5.Document">
                  <p:embed/>
                </p:oleObj>
              </mc:Choice>
              <mc:Fallback>
                <p:oleObj name="Prism 5" r:id="rId3" imgW="3849480" imgH="26470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70363" y="2105025"/>
                        <a:ext cx="3849687" cy="2646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ZoneTexte 9"/>
          <p:cNvSpPr txBox="1"/>
          <p:nvPr/>
        </p:nvSpPr>
        <p:spPr>
          <a:xfrm>
            <a:off x="1734403" y="4751388"/>
            <a:ext cx="829490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fr-FR" sz="1100" b="1" smtClean="0">
                <a:latin typeface="Arial" panose="020B0604020202020204" pitchFamily="34" charset="0"/>
                <a:cs typeface="Arial" panose="020B0604020202020204" pitchFamily="34" charset="0"/>
              </a:rPr>
              <a:t>Fig: 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fficacy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VV on 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normal canine 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mmary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ithelial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normal canine </a:t>
            </a:r>
            <a:r>
              <a:rPr lang="fr-F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mmary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ithelial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s were infected at different MOIs with VV. Fours days later, the remaining cells were estimated using a MTT assay. The results are presented as a percentage of cell-survival in uninfected cells and are mean +/- SEM of six different experimental points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is result is representative of two independent determinations.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1973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5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5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orges I</dc:creator>
  <cp:lastModifiedBy>Georges I</cp:lastModifiedBy>
  <cp:revision>5</cp:revision>
  <dcterms:created xsi:type="dcterms:W3CDTF">2020-07-23T13:04:32Z</dcterms:created>
  <dcterms:modified xsi:type="dcterms:W3CDTF">2020-10-01T13:22:32Z</dcterms:modified>
</cp:coreProperties>
</file>